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ander Dils" initials="AD" lastIdx="1" clrIdx="0">
    <p:extLst>
      <p:ext uri="{19B8F6BF-5375-455C-9EA6-DF929625EA0E}">
        <p15:presenceInfo xmlns:p15="http://schemas.microsoft.com/office/powerpoint/2012/main" userId="c784099f4177c7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655" autoAdjust="0"/>
    <p:restoredTop sz="90062" autoAdjust="0"/>
  </p:normalViewPr>
  <p:slideViewPr>
    <p:cSldViewPr snapToGrid="0">
      <p:cViewPr varScale="1">
        <p:scale>
          <a:sx n="53" d="100"/>
          <a:sy n="53" d="100"/>
        </p:scale>
        <p:origin x="176" y="720"/>
      </p:cViewPr>
      <p:guideLst>
        <p:guide orient="horz" pos="112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7" d="100"/>
        <a:sy n="147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E029D0-E746-4642-BD9A-E771A539E169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1130CC-2589-4178-9C25-726388E64E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24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1130CC-2589-4178-9C25-726388E64E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0569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3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555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78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736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96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476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968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17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11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145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813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80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275" y="5538132"/>
            <a:ext cx="663072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Sel1L is not required for IL-7 dependent survival of T cel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127 surface expression on WT and Sel1LKO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mmary of CD127 MFI on WT and Sel1LKO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normalized to WT. B) Frequency of live cells (measured by L/D staining) among WT or Sel1LKO T cells after in vitro culture in the absence or presence of 10ng/ml IL-7 for 18hrs. C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racellular Bcl2 expression in WT and Sel1LKO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; right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FI of Bcl2 in naïve and CD4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from WT and Sel1LKO mice, normalized to WT of each subset. Data representative of n=10/genotype (A), n=5-6/genotype (B), 8-10/genotype (C), from 2 (B) or 3 (A, C) independent experiments.</a:t>
            </a:r>
          </a:p>
        </p:txBody>
      </p:sp>
      <p:grpSp>
        <p:nvGrpSpPr>
          <p:cNvPr id="78" name="Group 77">
            <a:extLst>
              <a:ext uri="{FF2B5EF4-FFF2-40B4-BE49-F238E27FC236}">
                <a16:creationId xmlns:a16="http://schemas.microsoft.com/office/drawing/2014/main" id="{2B9A6931-8A40-C343-9804-D5B5D483A89E}"/>
              </a:ext>
            </a:extLst>
          </p:cNvPr>
          <p:cNvGrpSpPr/>
          <p:nvPr/>
        </p:nvGrpSpPr>
        <p:grpSpPr>
          <a:xfrm>
            <a:off x="3113090" y="2836670"/>
            <a:ext cx="1794520" cy="1922125"/>
            <a:chOff x="5480621" y="4350540"/>
            <a:chExt cx="1794520" cy="1922125"/>
          </a:xfrm>
        </p:grpSpPr>
        <p:pic>
          <p:nvPicPr>
            <p:cNvPr id="79" name="Picture 78" descr="Chart, bar chart&#10;&#10;Description automatically generated">
              <a:extLst>
                <a:ext uri="{FF2B5EF4-FFF2-40B4-BE49-F238E27FC236}">
                  <a16:creationId xmlns:a16="http://schemas.microsoft.com/office/drawing/2014/main" id="{67A19D1C-606B-1E4B-9D4B-992FFEAD27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8370" y="4458772"/>
              <a:ext cx="1676771" cy="1408716"/>
            </a:xfrm>
            <a:prstGeom prst="rect">
              <a:avLst/>
            </a:prstGeom>
          </p:spPr>
        </p:pic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079246A2-5D3E-064C-8934-C7DCC72DD484}"/>
                </a:ext>
              </a:extLst>
            </p:cNvPr>
            <p:cNvGrpSpPr/>
            <p:nvPr/>
          </p:nvGrpSpPr>
          <p:grpSpPr>
            <a:xfrm>
              <a:off x="5480621" y="4350540"/>
              <a:ext cx="1567550" cy="1922125"/>
              <a:chOff x="1146599" y="1447994"/>
              <a:chExt cx="1567550" cy="1922125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B2E254A8-C61B-E242-AC32-AEBE50625EF8}"/>
                  </a:ext>
                </a:extLst>
              </p:cNvPr>
              <p:cNvGrpSpPr/>
              <p:nvPr/>
            </p:nvGrpSpPr>
            <p:grpSpPr>
              <a:xfrm>
                <a:off x="1532279" y="1623601"/>
                <a:ext cx="1181870" cy="1746518"/>
                <a:chOff x="1510412" y="1736016"/>
                <a:chExt cx="1181870" cy="1746518"/>
              </a:xfrm>
            </p:grpSpPr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DA5B5A54-1AAE-AE44-98CE-7193CF878DD7}"/>
                    </a:ext>
                  </a:extLst>
                </p:cNvPr>
                <p:cNvSpPr txBox="1"/>
                <p:nvPr/>
              </p:nvSpPr>
              <p:spPr>
                <a:xfrm rot="18863469">
                  <a:off x="1409066" y="3025608"/>
                  <a:ext cx="41870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aïve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19C93326-513B-2C42-9072-DFE8406CD405}"/>
                    </a:ext>
                  </a:extLst>
                </p:cNvPr>
                <p:cNvSpPr txBox="1"/>
                <p:nvPr/>
              </p:nvSpPr>
              <p:spPr>
                <a:xfrm rot="18863469">
                  <a:off x="1640837" y="3053100"/>
                  <a:ext cx="45878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  <a:r>
                    <a:rPr lang="en-US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4C98921-3F3F-ED4D-BA03-791A98A34AE4}"/>
                    </a:ext>
                  </a:extLst>
                </p:cNvPr>
                <p:cNvSpPr txBox="1"/>
                <p:nvPr/>
              </p:nvSpPr>
              <p:spPr>
                <a:xfrm rot="18863469">
                  <a:off x="1968262" y="3025608"/>
                  <a:ext cx="41870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aïve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52E80204-8A7C-DE45-A8DE-51624E200D36}"/>
                    </a:ext>
                  </a:extLst>
                </p:cNvPr>
                <p:cNvSpPr txBox="1"/>
                <p:nvPr/>
              </p:nvSpPr>
              <p:spPr>
                <a:xfrm rot="18863469">
                  <a:off x="2195831" y="3053100"/>
                  <a:ext cx="45878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  <a:r>
                    <a:rPr lang="en-US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7509CDB2-3A34-7845-B899-AE1BC71B3887}"/>
                    </a:ext>
                  </a:extLst>
                </p:cNvPr>
                <p:cNvSpPr txBox="1"/>
                <p:nvPr/>
              </p:nvSpPr>
              <p:spPr>
                <a:xfrm>
                  <a:off x="1571998" y="3282479"/>
                  <a:ext cx="3626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67B00319-56CA-284A-9BA5-D122CA62F41A}"/>
                    </a:ext>
                  </a:extLst>
                </p:cNvPr>
                <p:cNvSpPr txBox="1"/>
                <p:nvPr/>
              </p:nvSpPr>
              <p:spPr>
                <a:xfrm>
                  <a:off x="2152025" y="3282479"/>
                  <a:ext cx="3626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</a:p>
              </p:txBody>
            </p:sp>
            <p:cxnSp>
              <p:nvCxnSpPr>
                <p:cNvPr id="90" name="Straight Connector 89">
                  <a:extLst>
                    <a:ext uri="{FF2B5EF4-FFF2-40B4-BE49-F238E27FC236}">
                      <a16:creationId xmlns:a16="http://schemas.microsoft.com/office/drawing/2014/main" id="{0968CB53-592B-254C-92E3-A36B03B7A4E0}"/>
                    </a:ext>
                  </a:extLst>
                </p:cNvPr>
                <p:cNvCxnSpPr/>
                <p:nvPr/>
              </p:nvCxnSpPr>
              <p:spPr>
                <a:xfrm>
                  <a:off x="1510412" y="3294654"/>
                  <a:ext cx="455684" cy="33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Connector 90">
                  <a:extLst>
                    <a:ext uri="{FF2B5EF4-FFF2-40B4-BE49-F238E27FC236}">
                      <a16:creationId xmlns:a16="http://schemas.microsoft.com/office/drawing/2014/main" id="{F1CA495B-46B5-9241-98E1-A4BA60300EE4}"/>
                    </a:ext>
                  </a:extLst>
                </p:cNvPr>
                <p:cNvCxnSpPr/>
                <p:nvPr/>
              </p:nvCxnSpPr>
              <p:spPr>
                <a:xfrm>
                  <a:off x="2111321" y="3297033"/>
                  <a:ext cx="455684" cy="33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16DEF678-8D57-7641-B30E-5A5728C0E968}"/>
                    </a:ext>
                  </a:extLst>
                </p:cNvPr>
                <p:cNvSpPr txBox="1"/>
                <p:nvPr/>
              </p:nvSpPr>
              <p:spPr>
                <a:xfrm>
                  <a:off x="2080867" y="1736016"/>
                  <a:ext cx="3193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cxnSp>
              <p:nvCxnSpPr>
                <p:cNvPr id="93" name="Straight Connector 92">
                  <a:extLst>
                    <a:ext uri="{FF2B5EF4-FFF2-40B4-BE49-F238E27FC236}">
                      <a16:creationId xmlns:a16="http://schemas.microsoft.com/office/drawing/2014/main" id="{08EF212C-663F-C84E-88B2-507A46686A3B}"/>
                    </a:ext>
                  </a:extLst>
                </p:cNvPr>
                <p:cNvCxnSpPr/>
                <p:nvPr/>
              </p:nvCxnSpPr>
              <p:spPr>
                <a:xfrm>
                  <a:off x="2150056" y="1872868"/>
                  <a:ext cx="176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391A5F10-8DC9-EF40-BBC8-25B852CD7F18}"/>
                    </a:ext>
                  </a:extLst>
                </p:cNvPr>
                <p:cNvSpPr txBox="1"/>
                <p:nvPr/>
              </p:nvSpPr>
              <p:spPr>
                <a:xfrm>
                  <a:off x="2372963" y="1913193"/>
                  <a:ext cx="3193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cxnSp>
              <p:nvCxnSpPr>
                <p:cNvPr id="95" name="Straight Connector 94">
                  <a:extLst>
                    <a:ext uri="{FF2B5EF4-FFF2-40B4-BE49-F238E27FC236}">
                      <a16:creationId xmlns:a16="http://schemas.microsoft.com/office/drawing/2014/main" id="{954325E8-27C7-9E4C-80FC-722D6C157601}"/>
                    </a:ext>
                  </a:extLst>
                </p:cNvPr>
                <p:cNvCxnSpPr/>
                <p:nvPr/>
              </p:nvCxnSpPr>
              <p:spPr>
                <a:xfrm>
                  <a:off x="2442152" y="2050045"/>
                  <a:ext cx="176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D3B70B2D-CD6B-2945-BB5D-AEA7CC4AD672}"/>
                    </a:ext>
                  </a:extLst>
                </p:cNvPr>
                <p:cNvSpPr txBox="1"/>
                <p:nvPr/>
              </p:nvSpPr>
              <p:spPr>
                <a:xfrm>
                  <a:off x="1870149" y="2244189"/>
                  <a:ext cx="22955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cxnSp>
              <p:nvCxnSpPr>
                <p:cNvPr id="97" name="Straight Connector 96">
                  <a:extLst>
                    <a:ext uri="{FF2B5EF4-FFF2-40B4-BE49-F238E27FC236}">
                      <a16:creationId xmlns:a16="http://schemas.microsoft.com/office/drawing/2014/main" id="{C75B3B37-2415-834E-9080-9939F8278D47}"/>
                    </a:ext>
                  </a:extLst>
                </p:cNvPr>
                <p:cNvCxnSpPr/>
                <p:nvPr/>
              </p:nvCxnSpPr>
              <p:spPr>
                <a:xfrm>
                  <a:off x="1894454" y="2381041"/>
                  <a:ext cx="176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10EBBD6D-0785-DE49-9F43-B077E0F39151}"/>
                    </a:ext>
                  </a:extLst>
                </p:cNvPr>
                <p:cNvSpPr txBox="1"/>
                <p:nvPr/>
              </p:nvSpPr>
              <p:spPr>
                <a:xfrm>
                  <a:off x="1537286" y="1844123"/>
                  <a:ext cx="3193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cxnSp>
              <p:nvCxnSpPr>
                <p:cNvPr id="99" name="Straight Connector 98">
                  <a:extLst>
                    <a:ext uri="{FF2B5EF4-FFF2-40B4-BE49-F238E27FC236}">
                      <a16:creationId xmlns:a16="http://schemas.microsoft.com/office/drawing/2014/main" id="{4C2B1A48-3265-B941-9E19-AA8DB9084F29}"/>
                    </a:ext>
                  </a:extLst>
                </p:cNvPr>
                <p:cNvCxnSpPr/>
                <p:nvPr/>
              </p:nvCxnSpPr>
              <p:spPr>
                <a:xfrm>
                  <a:off x="1606475" y="1980975"/>
                  <a:ext cx="176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30993AF4-D111-2043-8F65-C65D9828819C}"/>
                  </a:ext>
                </a:extLst>
              </p:cNvPr>
              <p:cNvSpPr txBox="1"/>
              <p:nvPr/>
            </p:nvSpPr>
            <p:spPr>
              <a:xfrm>
                <a:off x="2044574" y="1447994"/>
                <a:ext cx="1847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endParaRPr lang="en-US" sz="8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AB694923-8044-1648-939C-EE04174934D4}"/>
                  </a:ext>
                </a:extLst>
              </p:cNvPr>
              <p:cNvSpPr txBox="1"/>
              <p:nvPr/>
            </p:nvSpPr>
            <p:spPr>
              <a:xfrm rot="16200000">
                <a:off x="691100" y="2118937"/>
                <a:ext cx="12187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FI Bcl2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over WT</a:t>
                </a:r>
              </a:p>
            </p:txBody>
          </p:sp>
        </p:grp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ADF228F5-4582-3F40-8700-8AB85373BF1C}"/>
              </a:ext>
            </a:extLst>
          </p:cNvPr>
          <p:cNvGrpSpPr/>
          <p:nvPr/>
        </p:nvGrpSpPr>
        <p:grpSpPr>
          <a:xfrm>
            <a:off x="1212122" y="796406"/>
            <a:ext cx="2139517" cy="1621610"/>
            <a:chOff x="143094" y="4593053"/>
            <a:chExt cx="2139517" cy="1621610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B824BFF4-FD63-7D44-A21C-A27C381651D0}"/>
                </a:ext>
              </a:extLst>
            </p:cNvPr>
            <p:cNvGrpSpPr/>
            <p:nvPr/>
          </p:nvGrpSpPr>
          <p:grpSpPr>
            <a:xfrm>
              <a:off x="143094" y="4593053"/>
              <a:ext cx="2139517" cy="1621610"/>
              <a:chOff x="50293" y="4200572"/>
              <a:chExt cx="2139517" cy="1621610"/>
            </a:xfrm>
          </p:grpSpPr>
          <p:pic>
            <p:nvPicPr>
              <p:cNvPr id="105" name="Picture 104" descr="Chart, bar chart&#10;&#10;Description automatically generated">
                <a:extLst>
                  <a:ext uri="{FF2B5EF4-FFF2-40B4-BE49-F238E27FC236}">
                    <a16:creationId xmlns:a16="http://schemas.microsoft.com/office/drawing/2014/main" id="{977AB332-7A05-974F-AC4F-F84104C756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88097" y="4331506"/>
                <a:ext cx="1001713" cy="1326060"/>
              </a:xfrm>
              <a:prstGeom prst="rect">
                <a:avLst/>
              </a:prstGeom>
            </p:spPr>
          </p:pic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92552E3F-B28D-034B-B7D4-CBBAAE05B476}"/>
                  </a:ext>
                </a:extLst>
              </p:cNvPr>
              <p:cNvGrpSpPr/>
              <p:nvPr/>
            </p:nvGrpSpPr>
            <p:grpSpPr>
              <a:xfrm>
                <a:off x="50293" y="4200572"/>
                <a:ext cx="2073550" cy="1621610"/>
                <a:chOff x="127238" y="4997812"/>
                <a:chExt cx="2073550" cy="1621610"/>
              </a:xfrm>
            </p:grpSpPr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22E50827-9648-2D46-B31B-44C759E28EC6}"/>
                    </a:ext>
                  </a:extLst>
                </p:cNvPr>
                <p:cNvGrpSpPr/>
                <p:nvPr/>
              </p:nvGrpSpPr>
              <p:grpSpPr>
                <a:xfrm>
                  <a:off x="1064637" y="5171946"/>
                  <a:ext cx="1136151" cy="1382326"/>
                  <a:chOff x="4234685" y="6434131"/>
                  <a:chExt cx="1136151" cy="1382326"/>
                </a:xfrm>
              </p:grpSpPr>
              <p:grpSp>
                <p:nvGrpSpPr>
                  <p:cNvPr id="116" name="Group 115">
                    <a:extLst>
                      <a:ext uri="{FF2B5EF4-FFF2-40B4-BE49-F238E27FC236}">
                        <a16:creationId xmlns:a16="http://schemas.microsoft.com/office/drawing/2014/main" id="{D00FB7C9-9F3D-6B40-AC72-E036DC19DD28}"/>
                      </a:ext>
                    </a:extLst>
                  </p:cNvPr>
                  <p:cNvGrpSpPr/>
                  <p:nvPr/>
                </p:nvGrpSpPr>
                <p:grpSpPr>
                  <a:xfrm>
                    <a:off x="4676676" y="6434131"/>
                    <a:ext cx="694160" cy="1382326"/>
                    <a:chOff x="5237995" y="6220356"/>
                    <a:chExt cx="694160" cy="1382326"/>
                  </a:xfrm>
                </p:grpSpPr>
                <p:grpSp>
                  <p:nvGrpSpPr>
                    <p:cNvPr id="119" name="Group 118">
                      <a:extLst>
                        <a:ext uri="{FF2B5EF4-FFF2-40B4-BE49-F238E27FC236}">
                          <a16:creationId xmlns:a16="http://schemas.microsoft.com/office/drawing/2014/main" id="{DF86C9CD-CCB4-0C42-ACC0-D798870D55B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589649" y="6220356"/>
                      <a:ext cx="319319" cy="230832"/>
                      <a:chOff x="2709839" y="860797"/>
                      <a:chExt cx="319319" cy="230832"/>
                    </a:xfrm>
                  </p:grpSpPr>
                  <p:sp>
                    <p:nvSpPr>
                      <p:cNvPr id="122" name="TextBox 121">
                        <a:extLst>
                          <a:ext uri="{FF2B5EF4-FFF2-40B4-BE49-F238E27FC236}">
                            <a16:creationId xmlns:a16="http://schemas.microsoft.com/office/drawing/2014/main" id="{278CE53E-4442-1D44-863D-A280B2ECDD7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09839" y="860797"/>
                        <a:ext cx="319319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***</a:t>
                        </a:r>
                      </a:p>
                    </p:txBody>
                  </p:sp>
                  <p:cxnSp>
                    <p:nvCxnSpPr>
                      <p:cNvPr id="123" name="Straight Connector 122">
                        <a:extLst>
                          <a:ext uri="{FF2B5EF4-FFF2-40B4-BE49-F238E27FC236}">
                            <a16:creationId xmlns:a16="http://schemas.microsoft.com/office/drawing/2014/main" id="{939FCECF-3E1D-3548-9B73-56CEA77A78E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79028" y="997649"/>
                        <a:ext cx="176178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20" name="TextBox 119">
                      <a:extLst>
                        <a:ext uri="{FF2B5EF4-FFF2-40B4-BE49-F238E27FC236}">
                          <a16:creationId xmlns:a16="http://schemas.microsoft.com/office/drawing/2014/main" id="{3A3325BF-52E0-4C46-A74D-81D5238534C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7995" y="7402627"/>
                      <a:ext cx="36260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</p:txBody>
                </p:sp>
                <p:sp>
                  <p:nvSpPr>
                    <p:cNvPr id="121" name="TextBox 120">
                      <a:extLst>
                        <a:ext uri="{FF2B5EF4-FFF2-40B4-BE49-F238E27FC236}">
                          <a16:creationId xmlns:a16="http://schemas.microsoft.com/office/drawing/2014/main" id="{27C198D3-3D86-614E-B60A-AFFEA5FD16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69555" y="7402627"/>
                      <a:ext cx="36260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p:txBody>
                </p:sp>
              </p:grpSp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C27E1C01-6ADD-5B4C-A5E8-6F9C293079B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857819" y="6914445"/>
                    <a:ext cx="106150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FI CD127</a:t>
                    </a:r>
                  </a:p>
                  <a:p>
                    <a:pPr algn="ctr"/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ld Change over WT</a:t>
                    </a:r>
                  </a:p>
                </p:txBody>
              </p:sp>
            </p:grpSp>
            <p:grpSp>
              <p:nvGrpSpPr>
                <p:cNvPr id="108" name="Group 107">
                  <a:extLst>
                    <a:ext uri="{FF2B5EF4-FFF2-40B4-BE49-F238E27FC236}">
                      <a16:creationId xmlns:a16="http://schemas.microsoft.com/office/drawing/2014/main" id="{C022D437-2B06-344D-8474-EC985CDF9069}"/>
                    </a:ext>
                  </a:extLst>
                </p:cNvPr>
                <p:cNvGrpSpPr/>
                <p:nvPr/>
              </p:nvGrpSpPr>
              <p:grpSpPr>
                <a:xfrm>
                  <a:off x="127238" y="4997812"/>
                  <a:ext cx="997090" cy="1621610"/>
                  <a:chOff x="494412" y="4560316"/>
                  <a:chExt cx="997090" cy="1621610"/>
                </a:xfrm>
              </p:grpSpPr>
              <p:grpSp>
                <p:nvGrpSpPr>
                  <p:cNvPr id="109" name="Group 108">
                    <a:extLst>
                      <a:ext uri="{FF2B5EF4-FFF2-40B4-BE49-F238E27FC236}">
                        <a16:creationId xmlns:a16="http://schemas.microsoft.com/office/drawing/2014/main" id="{412D8DA9-851B-914B-956D-7765F3A1CBE2}"/>
                      </a:ext>
                    </a:extLst>
                  </p:cNvPr>
                  <p:cNvGrpSpPr/>
                  <p:nvPr/>
                </p:nvGrpSpPr>
                <p:grpSpPr>
                  <a:xfrm>
                    <a:off x="494412" y="4560316"/>
                    <a:ext cx="937399" cy="1621610"/>
                    <a:chOff x="4435021" y="5136515"/>
                    <a:chExt cx="937399" cy="1621610"/>
                  </a:xfrm>
                </p:grpSpPr>
                <p:sp>
                  <p:nvSpPr>
                    <p:cNvPr id="113" name="TextBox 112">
                      <a:extLst>
                        <a:ext uri="{FF2B5EF4-FFF2-40B4-BE49-F238E27FC236}">
                          <a16:creationId xmlns:a16="http://schemas.microsoft.com/office/drawing/2014/main" id="{172EB20E-EFEF-7047-9173-CFCD4382D61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1902" y="5858828"/>
                      <a:ext cx="73988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p:txBody>
                </p:sp>
                <p:sp>
                  <p:nvSpPr>
                    <p:cNvPr id="114" name="TextBox 113">
                      <a:extLst>
                        <a:ext uri="{FF2B5EF4-FFF2-40B4-BE49-F238E27FC236}">
                          <a16:creationId xmlns:a16="http://schemas.microsoft.com/office/drawing/2014/main" id="{27B35659-430A-1B4C-8E94-D5840834B9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67825" y="6558070"/>
                      <a:ext cx="46198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27</a:t>
                      </a:r>
                    </a:p>
                  </p:txBody>
                </p: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FA4BE8AB-77B7-A94C-A3C8-69236BEA541A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041163" y="5774049"/>
                      <a:ext cx="98777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ized to Mode</a:t>
                      </a:r>
                    </a:p>
                  </p:txBody>
                </p:sp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373E1623-BDEE-9340-A069-A7D6C9D63B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1903" y="5136515"/>
                      <a:ext cx="74051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</p:txBody>
                </p:sp>
              </p:grpSp>
              <p:pic>
                <p:nvPicPr>
                  <p:cNvPr id="110" name="Picture 109" descr="A picture containing icon&#10;&#10;Description automatically generated">
                    <a:extLst>
                      <a:ext uri="{FF2B5EF4-FFF2-40B4-BE49-F238E27FC236}">
                        <a16:creationId xmlns:a16="http://schemas.microsoft.com/office/drawing/2014/main" id="{6E9F1DB3-FD61-4643-BE1C-976D84633F6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6132" y="5348314"/>
                    <a:ext cx="912696" cy="727259"/>
                  </a:xfrm>
                  <a:prstGeom prst="rect">
                    <a:avLst/>
                  </a:prstGeom>
                </p:spPr>
              </p:pic>
              <p:pic>
                <p:nvPicPr>
                  <p:cNvPr id="111" name="Picture 110" descr="A picture containing icon&#10;&#10;Description automatically generated">
                    <a:extLst>
                      <a:ext uri="{FF2B5EF4-FFF2-40B4-BE49-F238E27FC236}">
                        <a16:creationId xmlns:a16="http://schemas.microsoft.com/office/drawing/2014/main" id="{851B8081-A3EE-4447-8A7D-BBC8F3EB153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3458" y="4612836"/>
                    <a:ext cx="918044" cy="731520"/>
                  </a:xfrm>
                  <a:prstGeom prst="rect">
                    <a:avLst/>
                  </a:prstGeom>
                </p:spPr>
              </p:pic>
            </p:grpSp>
          </p:grp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D502E46C-EF3A-0A47-87B7-90DFDA8C61D8}"/>
                </a:ext>
              </a:extLst>
            </p:cNvPr>
            <p:cNvGrpSpPr/>
            <p:nvPr/>
          </p:nvGrpSpPr>
          <p:grpSpPr>
            <a:xfrm>
              <a:off x="1534502" y="4703052"/>
              <a:ext cx="319319" cy="230832"/>
              <a:chOff x="1432975" y="4283298"/>
              <a:chExt cx="319319" cy="230832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7D860B00-B616-E54F-8800-D421BCA255C7}"/>
                  </a:ext>
                </a:extLst>
              </p:cNvPr>
              <p:cNvSpPr txBox="1"/>
              <p:nvPr/>
            </p:nvSpPr>
            <p:spPr>
              <a:xfrm>
                <a:off x="1432975" y="4283298"/>
                <a:ext cx="3193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3135171A-CF69-0E40-BAF2-E04806C11E42}"/>
                  </a:ext>
                </a:extLst>
              </p:cNvPr>
              <p:cNvCxnSpPr/>
              <p:nvPr/>
            </p:nvCxnSpPr>
            <p:spPr>
              <a:xfrm>
                <a:off x="1502164" y="4420150"/>
                <a:ext cx="1761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B003DA6A-715F-9E46-9944-DA03BF3451C1}"/>
              </a:ext>
            </a:extLst>
          </p:cNvPr>
          <p:cNvGrpSpPr/>
          <p:nvPr/>
        </p:nvGrpSpPr>
        <p:grpSpPr>
          <a:xfrm>
            <a:off x="1979879" y="2960263"/>
            <a:ext cx="996924" cy="1583498"/>
            <a:chOff x="-1837886" y="4489844"/>
            <a:chExt cx="996924" cy="1583498"/>
          </a:xfrm>
        </p:grpSpPr>
        <p:pic>
          <p:nvPicPr>
            <p:cNvPr id="137" name="Picture 136" descr="A picture containing shape&#10;&#10;Description automatically generated">
              <a:extLst>
                <a:ext uri="{FF2B5EF4-FFF2-40B4-BE49-F238E27FC236}">
                  <a16:creationId xmlns:a16="http://schemas.microsoft.com/office/drawing/2014/main" id="{287528A5-FE77-874D-A263-5719922872A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722072" y="4566613"/>
              <a:ext cx="869679" cy="692982"/>
            </a:xfrm>
            <a:prstGeom prst="rect">
              <a:avLst/>
            </a:prstGeom>
          </p:spPr>
        </p:pic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D6939B76-3D63-554C-8BAB-1704542A99FD}"/>
                </a:ext>
              </a:extLst>
            </p:cNvPr>
            <p:cNvSpPr txBox="1"/>
            <p:nvPr/>
          </p:nvSpPr>
          <p:spPr>
            <a:xfrm>
              <a:off x="-1447246" y="4489844"/>
              <a:ext cx="3626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C633C1CA-C0C2-AD48-8566-716C83D3CE83}"/>
                </a:ext>
              </a:extLst>
            </p:cNvPr>
            <p:cNvSpPr txBox="1"/>
            <p:nvPr/>
          </p:nvSpPr>
          <p:spPr>
            <a:xfrm>
              <a:off x="-1444841" y="5873287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Bcl2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6C5F179E-F807-1B43-B3BC-7977B6CB9CA5}"/>
                </a:ext>
              </a:extLst>
            </p:cNvPr>
            <p:cNvSpPr txBox="1"/>
            <p:nvPr/>
          </p:nvSpPr>
          <p:spPr>
            <a:xfrm rot="16200000">
              <a:off x="-2231744" y="5190372"/>
              <a:ext cx="98777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ormalized to Mode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D541CFDE-8B3D-604B-98C7-D9BF381BD1BA}"/>
                </a:ext>
              </a:extLst>
            </p:cNvPr>
            <p:cNvSpPr txBox="1"/>
            <p:nvPr/>
          </p:nvSpPr>
          <p:spPr>
            <a:xfrm>
              <a:off x="-1447246" y="5188514"/>
              <a:ext cx="3626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pic>
          <p:nvPicPr>
            <p:cNvPr id="142" name="Picture 141" descr="A picture containing histogram&#10;&#10;Description automatically generated">
              <a:extLst>
                <a:ext uri="{FF2B5EF4-FFF2-40B4-BE49-F238E27FC236}">
                  <a16:creationId xmlns:a16="http://schemas.microsoft.com/office/drawing/2014/main" id="{BA22B175-C5AA-EE4A-B2E9-806897C7CD0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733503" y="5250643"/>
              <a:ext cx="892541" cy="711199"/>
            </a:xfrm>
            <a:prstGeom prst="rect">
              <a:avLst/>
            </a:prstGeom>
          </p:spPr>
        </p:pic>
      </p:grpSp>
      <p:sp>
        <p:nvSpPr>
          <p:cNvPr id="143" name="TextBox 142">
            <a:extLst>
              <a:ext uri="{FF2B5EF4-FFF2-40B4-BE49-F238E27FC236}">
                <a16:creationId xmlns:a16="http://schemas.microsoft.com/office/drawing/2014/main" id="{E07B7B2B-195B-0846-BF8C-26193B26AD90}"/>
              </a:ext>
            </a:extLst>
          </p:cNvPr>
          <p:cNvSpPr txBox="1"/>
          <p:nvPr/>
        </p:nvSpPr>
        <p:spPr>
          <a:xfrm>
            <a:off x="1122002" y="690142"/>
            <a:ext cx="477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3488C91C-D44D-C44C-BC1A-8DE5DA6F48C9}"/>
              </a:ext>
            </a:extLst>
          </p:cNvPr>
          <p:cNvSpPr txBox="1"/>
          <p:nvPr/>
        </p:nvSpPr>
        <p:spPr>
          <a:xfrm>
            <a:off x="1700468" y="2857403"/>
            <a:ext cx="426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B70F045C-5527-F740-80B5-AC67EBD89D40}"/>
              </a:ext>
            </a:extLst>
          </p:cNvPr>
          <p:cNvSpPr txBox="1"/>
          <p:nvPr/>
        </p:nvSpPr>
        <p:spPr>
          <a:xfrm>
            <a:off x="3399559" y="690142"/>
            <a:ext cx="527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E8571B0-630C-C04C-BE1E-8CEAE14B8C15}"/>
              </a:ext>
            </a:extLst>
          </p:cNvPr>
          <p:cNvGrpSpPr/>
          <p:nvPr/>
        </p:nvGrpSpPr>
        <p:grpSpPr>
          <a:xfrm>
            <a:off x="3637244" y="842631"/>
            <a:ext cx="1644393" cy="1634978"/>
            <a:chOff x="3617366" y="812814"/>
            <a:chExt cx="1644393" cy="1634978"/>
          </a:xfrm>
        </p:grpSpPr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19D4695B-7005-FF46-BB64-650CDF045A97}"/>
                </a:ext>
              </a:extLst>
            </p:cNvPr>
            <p:cNvGrpSpPr/>
            <p:nvPr/>
          </p:nvGrpSpPr>
          <p:grpSpPr>
            <a:xfrm>
              <a:off x="3653015" y="812814"/>
              <a:ext cx="1608744" cy="1634978"/>
              <a:chOff x="3001292" y="4552945"/>
              <a:chExt cx="1608744" cy="1634978"/>
            </a:xfrm>
          </p:grpSpPr>
          <p:pic>
            <p:nvPicPr>
              <p:cNvPr id="125" name="Picture 124" descr="Chart, bar chart&#10;&#10;Description automatically generated">
                <a:extLst>
                  <a:ext uri="{FF2B5EF4-FFF2-40B4-BE49-F238E27FC236}">
                    <a16:creationId xmlns:a16="http://schemas.microsoft.com/office/drawing/2014/main" id="{6004FB92-2A93-2A47-A0B7-AEE247D120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81435" y="4552945"/>
                <a:ext cx="1528601" cy="1331247"/>
              </a:xfrm>
              <a:prstGeom prst="rect">
                <a:avLst/>
              </a:prstGeom>
            </p:spPr>
          </p:pic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5DA6A071-FA0B-E04F-B892-3547A1A8275C}"/>
                  </a:ext>
                </a:extLst>
              </p:cNvPr>
              <p:cNvSpPr txBox="1"/>
              <p:nvPr/>
            </p:nvSpPr>
            <p:spPr>
              <a:xfrm>
                <a:off x="3357097" y="5987868"/>
                <a:ext cx="4489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6E27BE75-FE3C-1848-9AB4-B974FE258214}"/>
                  </a:ext>
                </a:extLst>
              </p:cNvPr>
              <p:cNvSpPr txBox="1"/>
              <p:nvPr/>
            </p:nvSpPr>
            <p:spPr>
              <a:xfrm>
                <a:off x="3912298" y="5987868"/>
                <a:ext cx="45568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8012E9CC-3AC5-0448-AB85-61615EFB10B8}"/>
                  </a:ext>
                </a:extLst>
              </p:cNvPr>
              <p:cNvCxnSpPr/>
              <p:nvPr/>
            </p:nvCxnSpPr>
            <p:spPr>
              <a:xfrm>
                <a:off x="3350317" y="5982500"/>
                <a:ext cx="455684" cy="33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3CE5BC82-CA22-5941-9295-3FCC0A36E153}"/>
                  </a:ext>
                </a:extLst>
              </p:cNvPr>
              <p:cNvCxnSpPr/>
              <p:nvPr/>
            </p:nvCxnSpPr>
            <p:spPr>
              <a:xfrm>
                <a:off x="3912298" y="5982500"/>
                <a:ext cx="455684" cy="33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C126DCF5-BC13-EE45-8AB6-0849B5D9E598}"/>
                  </a:ext>
                </a:extLst>
              </p:cNvPr>
              <p:cNvSpPr txBox="1"/>
              <p:nvPr/>
            </p:nvSpPr>
            <p:spPr>
              <a:xfrm rot="16200000">
                <a:off x="2652318" y="5113016"/>
                <a:ext cx="89800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requency of Live</a:t>
                </a: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01BD33F-4028-6243-A33B-010084962ADE}"/>
                </a:ext>
              </a:extLst>
            </p:cNvPr>
            <p:cNvSpPr txBox="1"/>
            <p:nvPr/>
          </p:nvSpPr>
          <p:spPr>
            <a:xfrm>
              <a:off x="3617366" y="2067150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L-7: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4D6325B1-E052-D140-AA54-BBC5517BB4C8}"/>
              </a:ext>
            </a:extLst>
          </p:cNvPr>
          <p:cNvGrpSpPr/>
          <p:nvPr/>
        </p:nvGrpSpPr>
        <p:grpSpPr>
          <a:xfrm>
            <a:off x="1820541" y="932417"/>
            <a:ext cx="389301" cy="300951"/>
            <a:chOff x="-819558" y="680343"/>
            <a:chExt cx="389301" cy="300951"/>
          </a:xfrm>
        </p:grpSpPr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870176C7-0238-544C-9CF4-059FC98C819C}"/>
                </a:ext>
              </a:extLst>
            </p:cNvPr>
            <p:cNvSpPr/>
            <p:nvPr/>
          </p:nvSpPr>
          <p:spPr>
            <a:xfrm>
              <a:off x="-819558" y="728765"/>
              <a:ext cx="91440" cy="9144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DEFE3D30-DA66-BA46-8DDB-174E454CBA7C}"/>
                </a:ext>
              </a:extLst>
            </p:cNvPr>
            <p:cNvSpPr/>
            <p:nvPr/>
          </p:nvSpPr>
          <p:spPr>
            <a:xfrm>
              <a:off x="-819558" y="839425"/>
              <a:ext cx="91440" cy="91440"/>
            </a:xfrm>
            <a:prstGeom prst="rect">
              <a:avLst/>
            </a:prstGeom>
            <a:solidFill>
              <a:srgbClr val="AC0000">
                <a:alpha val="60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C617339-BDE9-3347-A70D-DE03AF058A97}"/>
                </a:ext>
              </a:extLst>
            </p:cNvPr>
            <p:cNvSpPr txBox="1"/>
            <p:nvPr/>
          </p:nvSpPr>
          <p:spPr>
            <a:xfrm>
              <a:off x="-754385" y="680343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02D9366-A60A-D145-AE08-43412A68EA83}"/>
                </a:ext>
              </a:extLst>
            </p:cNvPr>
            <p:cNvSpPr txBox="1"/>
            <p:nvPr/>
          </p:nvSpPr>
          <p:spPr>
            <a:xfrm>
              <a:off x="-756852" y="781239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</p:grpSp>
      <p:sp>
        <p:nvSpPr>
          <p:cNvPr id="118" name="TextBox 117">
            <a:extLst>
              <a:ext uri="{FF2B5EF4-FFF2-40B4-BE49-F238E27FC236}">
                <a16:creationId xmlns:a16="http://schemas.microsoft.com/office/drawing/2014/main" id="{A51CA1C9-E11C-114A-9E57-991652F3FA37}"/>
              </a:ext>
            </a:extLst>
          </p:cNvPr>
          <p:cNvSpPr txBox="1"/>
          <p:nvPr/>
        </p:nvSpPr>
        <p:spPr>
          <a:xfrm>
            <a:off x="4021918" y="2053325"/>
            <a:ext cx="2311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1086700A-FEBB-8E41-B981-F5E862786213}"/>
              </a:ext>
            </a:extLst>
          </p:cNvPr>
          <p:cNvSpPr txBox="1"/>
          <p:nvPr/>
        </p:nvSpPr>
        <p:spPr>
          <a:xfrm>
            <a:off x="4277570" y="2055074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671859A4-C9D3-174B-8C35-88E3792638A1}"/>
              </a:ext>
            </a:extLst>
          </p:cNvPr>
          <p:cNvSpPr txBox="1"/>
          <p:nvPr/>
        </p:nvSpPr>
        <p:spPr>
          <a:xfrm>
            <a:off x="4561263" y="2049826"/>
            <a:ext cx="2311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B8CABFEB-A8D0-F544-A7F7-0912C2DC590A}"/>
              </a:ext>
            </a:extLst>
          </p:cNvPr>
          <p:cNvSpPr txBox="1"/>
          <p:nvPr/>
        </p:nvSpPr>
        <p:spPr>
          <a:xfrm>
            <a:off x="4816915" y="2051575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836963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45</TotalTime>
  <Words>242</Words>
  <Application>Microsoft Macintosh PowerPoint</Application>
  <PresentationFormat>Letter Paper (8.5x11 in)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>University of Michigan Health System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Carty, Shannon</dc:creator>
  <cp:keywords/>
  <dc:description/>
  <cp:lastModifiedBy>Carty, Shannon</cp:lastModifiedBy>
  <cp:revision>458</cp:revision>
  <cp:lastPrinted>2021-04-26T17:38:41Z</cp:lastPrinted>
  <dcterms:created xsi:type="dcterms:W3CDTF">2020-10-13T17:58:26Z</dcterms:created>
  <dcterms:modified xsi:type="dcterms:W3CDTF">2021-05-22T21:59:52Z</dcterms:modified>
  <cp:category/>
</cp:coreProperties>
</file>